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735600" cy="9867960"/>
          </a:xfrm>
          <a:custGeom>
            <a:avLst/>
            <a:gdLst>
              <a:gd name="textAreaLeft" fmla="*/ 360 w 6735600"/>
              <a:gd name="textAreaRight" fmla="*/ 6735240 w 6735600"/>
              <a:gd name="textAreaTop" fmla="*/ 360 h 9867960"/>
              <a:gd name="textAreaBottom" fmla="*/ 9867600 h 9867960"/>
            </a:gdLst>
            <a:ahLst/>
            <a:rect l="textAreaLeft" t="textAreaTop" r="textAreaRight" b="textAreaBottom"/>
            <a:pathLst>
              <a:path w="21600" h="31644">
                <a:moveTo>
                  <a:pt x="5" y="0"/>
                </a:moveTo>
                <a:arcTo wR="5" hR="5" stAng="16200000" swAng="-5400000"/>
                <a:lnTo>
                  <a:pt x="0" y="31639"/>
                </a:lnTo>
                <a:arcTo wR="5" hR="5" stAng="10800000" swAng="-5400000"/>
                <a:lnTo>
                  <a:pt x="21595" y="31644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1492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sldImg"/>
          </p:nvPr>
        </p:nvSpPr>
        <p:spPr>
          <a:xfrm>
            <a:off x="695160" y="739440"/>
            <a:ext cx="5343840" cy="369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673200" y="4686120"/>
            <a:ext cx="5387760" cy="443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2"/>
          </p:nvPr>
        </p:nvSpPr>
        <p:spPr>
          <a:xfrm>
            <a:off x="3814560" y="9370800"/>
            <a:ext cx="291780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36467A47-6D0C-4AB6-B545-ED28061EF23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695160" y="739800"/>
            <a:ext cx="5345280" cy="370044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4C2A8668-6A71-45CA-909D-2C03106CE7DF}" type="slidenum"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F7B9D9F-7738-47A9-9CFD-56C1458BE38F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D51BA83-C713-42B0-B272-FCD68C50D781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D891C9C-266E-463B-A535-83B9704B11DC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28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284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36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28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284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5156424-E1D1-40A5-9D4B-B8F71081E3A5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96367D2-EC37-42ED-A7FD-F88C710EDB9B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8507BFF-9F7D-48BB-87E9-D86150B6C68B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2F32223-0EAE-4002-9A82-52439D356936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BBD44CE-1DB2-42AE-9B65-8DD4C12F0D5F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360" y="274680"/>
            <a:ext cx="891360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F25049F-5DBF-4CF0-80ED-1B2917F61D05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A418926-3219-4466-BD67-7DF4C0A724B1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916EED2-C049-4EDE-8B9A-9997E0408246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69D3736-A8B5-435A-8612-FD6B146F7948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95360" y="6245280"/>
            <a:ext cx="231120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384720" y="6245280"/>
            <a:ext cx="313668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7099200" y="6245280"/>
            <a:ext cx="230976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938A8683-2727-44E0-B66B-1927FB837EDA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1325520" y="1339920"/>
            <a:ext cx="7229520" cy="475452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240120" y="476280"/>
            <a:ext cx="6825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pping the abnormal junctions of EG10 copies i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delta mic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2360520" y="2007720"/>
            <a:ext cx="3640320" cy="324324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940280" y="2009880"/>
            <a:ext cx="50472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209680" y="1506600"/>
            <a:ext cx="497520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pping of M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508200" y="5610240"/>
            <a:ext cx="249264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sition of F read in EG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403920" y="3205440"/>
            <a:ext cx="249264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sition of R read in EG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160880" y="1998720"/>
            <a:ext cx="50328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500280" y="2009880"/>
            <a:ext cx="50328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828880" y="2009880"/>
            <a:ext cx="50472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621240" y="2633760"/>
            <a:ext cx="50472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376880" y="2370240"/>
            <a:ext cx="50472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321000" y="3892680"/>
            <a:ext cx="503280" cy="50328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289240" y="4292640"/>
            <a:ext cx="50328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289240" y="3738600"/>
            <a:ext cx="503280" cy="50328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649600" y="3573360"/>
            <a:ext cx="503280" cy="50328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720880" y="3718080"/>
            <a:ext cx="503280" cy="5029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720880" y="3017880"/>
            <a:ext cx="503280" cy="50472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289240" y="2946240"/>
            <a:ext cx="503280" cy="50328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289240" y="2730600"/>
            <a:ext cx="503280" cy="503280"/>
          </a:xfrm>
          <a:prstGeom prst="ellipse">
            <a:avLst/>
          </a:prstGeom>
          <a:noFill/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728880" y="6114960"/>
            <a:ext cx="588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bnormal junctions (554 MPs) were mapped as 14 spot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5440" y="44280"/>
            <a:ext cx="187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. Fig.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681960" y="1893960"/>
            <a:ext cx="644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i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929280" y="2262240"/>
            <a:ext cx="216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7361280" y="2262240"/>
            <a:ext cx="216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7000920" y="2262240"/>
            <a:ext cx="503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799400" y="2011320"/>
            <a:ext cx="58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M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184880" y="1898640"/>
            <a:ext cx="644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i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713640" y="1844640"/>
            <a:ext cx="1655640" cy="536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7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0T03:26:47Z</dcterms:created>
  <dc:creator>dgm2</dc:creator>
  <dc:description/>
  <dc:language>en-US</dc:language>
  <cp:lastModifiedBy>masumura</cp:lastModifiedBy>
  <cp:lastPrinted>2015-08-31T08:41:32Z</cp:lastPrinted>
  <dcterms:modified xsi:type="dcterms:W3CDTF">2015-10-01T07:44:08Z</dcterms:modified>
  <cp:revision>260</cp:revision>
  <dc:subject/>
  <dc:title>スライド 1</dc:title>
</cp:coreProperties>
</file>